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38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nghe Meng" userId="8ec5781b-3938-43df-a84f-730d81e9a524" providerId="ADAL" clId="{155FC1B5-C193-4084-A0CA-70A595B45B2F}"/>
    <pc:docChg chg="modSld">
      <pc:chgData name="Qinghe Meng" userId="8ec5781b-3938-43df-a84f-730d81e9a524" providerId="ADAL" clId="{155FC1B5-C193-4084-A0CA-70A595B45B2F}" dt="2023-04-24T13:12:24.683" v="22" actId="1076"/>
      <pc:docMkLst>
        <pc:docMk/>
      </pc:docMkLst>
      <pc:sldChg chg="modSp mod">
        <pc:chgData name="Qinghe Meng" userId="8ec5781b-3938-43df-a84f-730d81e9a524" providerId="ADAL" clId="{155FC1B5-C193-4084-A0CA-70A595B45B2F}" dt="2023-04-24T13:12:24.683" v="22" actId="1076"/>
        <pc:sldMkLst>
          <pc:docMk/>
          <pc:sldMk cId="109033036" sldId="259"/>
        </pc:sldMkLst>
        <pc:spChg chg="mod">
          <ac:chgData name="Qinghe Meng" userId="8ec5781b-3938-43df-a84f-730d81e9a524" providerId="ADAL" clId="{155FC1B5-C193-4084-A0CA-70A595B45B2F}" dt="2023-04-24T13:12:24.683" v="22" actId="1076"/>
          <ac:spMkLst>
            <pc:docMk/>
            <pc:sldMk cId="109033036" sldId="259"/>
            <ac:spMk id="2" creationId="{E202B03B-CC60-4037-88F0-4A53CA91C1C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2A43F-ED19-4ED1-B6F6-3A74E9E5A3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4FFE52-FB97-44B2-856D-785DB7866C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DAC2-AB10-4A2D-BFB4-D29B9CE7BB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111A1B-0AB5-4B91-B84C-29A037902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7F5822-1B97-47A5-B61A-4F5F1D360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2382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F9566E-909E-47DE-9A67-9B0B51D228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3F44D6-19D4-4699-B461-7544D452F1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422778-44BA-482B-ACE6-122A3FB47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947AA9-7505-480A-A57C-8C6FC813A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269AE9-85AC-4DD0-B1D6-519DD76F4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2346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45886A5-35A9-4389-9ECC-B0BA99B58F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BBA62A-9E4D-47F7-B690-FC08E6AD82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0BB02E-69B1-4C28-9CBF-8CA40E368B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A50C9B-3C59-4436-946D-BB3DB64C05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ECF7F8-D440-41A4-99A0-2027A609C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6400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35B90A-47D9-4C03-BA08-E972EE80E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2CB7D8-F7B3-4192-9523-AA7406F077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8DF962-C77A-4334-B361-43AC698C1D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14263A-16DC-4599-8004-4DF702C72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FB3ACE-5C28-4149-AF8A-9816D44D3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56199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E7600E-FF53-43E1-B954-D73816B116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92479D-51B3-4FAF-A04B-6CC82E52C4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577E4-F4AC-49C2-8602-2A2259E1C1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794826-F77B-4186-881C-B9508A405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B145A7-0E9B-40F9-9D63-896C701D5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1391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F2DD3C-C2A0-406F-A222-D6E767FF10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7FFF0C-6BF8-4280-B3EF-E6439561A7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50F718-15B9-4777-BC24-0FDAD380E2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351F84-946E-4259-9A95-4252A8A78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ED6756-2843-4FE1-8A1D-EBD06DC6EE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B94D456-820C-4BC8-A292-72828DEC3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01469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107AB2-2433-4D6C-9651-E73D24D7B7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D2A30A-D81B-48C6-8235-37032DAF6E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3262606-E775-405A-B157-E309F65623C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59BF343-FC42-40F9-B1E9-6DDF72D8F06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AAA6DE-512F-4D51-91FE-4422417CE23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B72ED74-EE91-42A9-9E50-AFD925B71D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710BCE7-FDC5-45DA-B5CA-1129E871E0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5A95E66-C0B6-4779-BA71-86AEB362A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04064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4AF70E-249E-406A-8811-C538F6F4E8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6C86468-CEB1-41BC-BABA-B13EDE032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BD02474-D30A-4193-8FB4-47F1D903A1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70A196-5C8E-43A7-B479-32F9E78768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082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78A96B-8D86-4365-A2C3-C3E3297A1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6E5D6AC-AF78-4CDC-95E2-561840DC9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FE89C4-36B9-4B69-93F0-7CE36E3AF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0871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E6A14-8731-47E4-A886-0CD5BB49C6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61AAF4-E142-4877-892F-62D6367136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A16540-CBC7-4625-A698-F827733144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6DC115-AF36-4ADD-A6CC-E61ACEA4B2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2406C7-E2DF-4D88-84BA-4715A5018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F9B84BE-3F39-4FE8-80B8-0D8F06F113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1288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D41B74-5A5E-40A2-A314-24D4673259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5519C3-3914-4C6D-BBC3-82C552502B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EA4D77C-9B47-4F89-8A90-F639E4DAB8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462A37-DB59-4113-AF0A-651FF9881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A4A594-C54D-4FF4-91BB-7E68235D3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9B4A9F-68E9-44FA-B0EF-6CCA2642B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2319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7C9706B-2666-4F61-A812-B4603941E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3DB2B9-16D3-4757-8F9B-7666608817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D7FD92-D765-43E8-918D-158145F5160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CBA629-2B48-4E11-AF8F-EEF2D079EB03}" type="datetimeFigureOut">
              <a:rPr lang="en-US" smtClean="0"/>
              <a:t>4/2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416847-3817-4A80-92E2-2707BE53764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5FB13C-A90D-45A4-9187-BE81B880A0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3561B-91B3-4E79-B567-66937C2612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47597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02B03B-CC60-4037-88F0-4A53CA91C1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9615" y="220699"/>
            <a:ext cx="9605345" cy="1325563"/>
          </a:xfrm>
        </p:spPr>
        <p:txBody>
          <a:bodyPr>
            <a:normAutofit/>
          </a:bodyPr>
          <a:lstStyle/>
          <a:p>
            <a:r>
              <a:rPr lang="en-US" sz="2800" dirty="0"/>
              <a:t>H&amp;E stain showing pyelonephritis in vehicle group in db/db mice 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3613F5F-94DD-40FC-9791-C83334260D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29902" y="1690688"/>
            <a:ext cx="4656168" cy="3651897"/>
          </a:xfrm>
          <a:prstGeom prst="rect">
            <a:avLst/>
          </a:prstGeom>
        </p:spPr>
      </p:pic>
      <p:pic>
        <p:nvPicPr>
          <p:cNvPr id="11" name="Content Placeholder 10">
            <a:extLst>
              <a:ext uri="{FF2B5EF4-FFF2-40B4-BE49-F238E27FC236}">
                <a16:creationId xmlns:a16="http://schemas.microsoft.com/office/drawing/2014/main" id="{BAD4BBE3-FDAA-4A0B-BCBA-7078115ED4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479394" y="1690688"/>
            <a:ext cx="4656169" cy="3651898"/>
          </a:xfr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B3466619-4410-4350-96FA-520E27F0020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5254" y="1690688"/>
            <a:ext cx="4656168" cy="3651897"/>
          </a:xfrm>
          <a:prstGeom prst="rect">
            <a:avLst/>
          </a:prstGeom>
        </p:spPr>
      </p:pic>
      <p:sp>
        <p:nvSpPr>
          <p:cNvPr id="14" name="Arrow: Right 13">
            <a:extLst>
              <a:ext uri="{FF2B5EF4-FFF2-40B4-BE49-F238E27FC236}">
                <a16:creationId xmlns:a16="http://schemas.microsoft.com/office/drawing/2014/main" id="{2EAF9BA4-70DD-4507-AF7B-E4A9230015BA}"/>
              </a:ext>
            </a:extLst>
          </p:cNvPr>
          <p:cNvSpPr/>
          <p:nvPr/>
        </p:nvSpPr>
        <p:spPr>
          <a:xfrm>
            <a:off x="1020639" y="1817066"/>
            <a:ext cx="275208" cy="115410"/>
          </a:xfrm>
          <a:prstGeom prst="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15" name="Arrow: Right 14">
            <a:extLst>
              <a:ext uri="{FF2B5EF4-FFF2-40B4-BE49-F238E27FC236}">
                <a16:creationId xmlns:a16="http://schemas.microsoft.com/office/drawing/2014/main" id="{B545EC0C-4510-487D-9EEA-89FA55270A05}"/>
              </a:ext>
            </a:extLst>
          </p:cNvPr>
          <p:cNvSpPr/>
          <p:nvPr/>
        </p:nvSpPr>
        <p:spPr>
          <a:xfrm>
            <a:off x="5375356" y="3926523"/>
            <a:ext cx="275208" cy="115410"/>
          </a:xfrm>
          <a:prstGeom prst="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16" name="Arrow: Right 15">
            <a:extLst>
              <a:ext uri="{FF2B5EF4-FFF2-40B4-BE49-F238E27FC236}">
                <a16:creationId xmlns:a16="http://schemas.microsoft.com/office/drawing/2014/main" id="{7E1E5A25-64B3-4687-B8D6-973E9CB1C5CA}"/>
              </a:ext>
            </a:extLst>
          </p:cNvPr>
          <p:cNvSpPr/>
          <p:nvPr/>
        </p:nvSpPr>
        <p:spPr>
          <a:xfrm>
            <a:off x="9947356" y="2133937"/>
            <a:ext cx="275208" cy="115410"/>
          </a:xfrm>
          <a:prstGeom prst="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17" name="Arrow: Right 16">
            <a:extLst>
              <a:ext uri="{FF2B5EF4-FFF2-40B4-BE49-F238E27FC236}">
                <a16:creationId xmlns:a16="http://schemas.microsoft.com/office/drawing/2014/main" id="{696656A1-BDE4-49C8-BB7F-CE9494677969}"/>
              </a:ext>
            </a:extLst>
          </p:cNvPr>
          <p:cNvSpPr/>
          <p:nvPr/>
        </p:nvSpPr>
        <p:spPr>
          <a:xfrm>
            <a:off x="12418952" y="3727348"/>
            <a:ext cx="275208" cy="115410"/>
          </a:xfrm>
          <a:prstGeom prst="rightArrow">
            <a:avLst/>
          </a:prstGeom>
          <a:solidFill>
            <a:srgbClr val="00B05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00B050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0F8C06C-5C9C-4AF8-94B7-696616A50250}"/>
              </a:ext>
            </a:extLst>
          </p:cNvPr>
          <p:cNvSpPr txBox="1"/>
          <p:nvPr/>
        </p:nvSpPr>
        <p:spPr>
          <a:xfrm>
            <a:off x="1560635" y="5631437"/>
            <a:ext cx="98500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trol/Vehicle (green arrow: neutrophils clusters)</a:t>
            </a:r>
          </a:p>
          <a:p>
            <a:r>
              <a:rPr lang="en-US" dirty="0"/>
              <a:t>Neutrophils clusters in renal pelvis and tubulointerstitium (evidence of pyelonephritis). </a:t>
            </a:r>
          </a:p>
        </p:txBody>
      </p:sp>
    </p:spTree>
    <p:extLst>
      <p:ext uri="{BB962C8B-B14F-4D97-AF65-F5344CB8AC3E}">
        <p14:creationId xmlns:p14="http://schemas.microsoft.com/office/powerpoint/2010/main" val="1090330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43</TotalTime>
  <Words>36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H&amp;E stain showing pyelonephritis in vehicle group in db/db mice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ye Suo</dc:creator>
  <cp:lastModifiedBy>Qinghe Meng</cp:lastModifiedBy>
  <cp:revision>4</cp:revision>
  <dcterms:created xsi:type="dcterms:W3CDTF">2023-01-30T19:06:35Z</dcterms:created>
  <dcterms:modified xsi:type="dcterms:W3CDTF">2023-04-24T13:12:24Z</dcterms:modified>
</cp:coreProperties>
</file>